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271" r:id="rId2"/>
    <p:sldId id="293" r:id="rId3"/>
    <p:sldId id="285" r:id="rId4"/>
    <p:sldId id="280" r:id="rId5"/>
    <p:sldId id="284" r:id="rId6"/>
    <p:sldId id="282" r:id="rId7"/>
    <p:sldId id="291" r:id="rId8"/>
    <p:sldId id="292" r:id="rId9"/>
  </p:sldIdLst>
  <p:sldSz cx="6858000" cy="9144000" type="letter"/>
  <p:notesSz cx="6807200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7E1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199" autoAdjust="0"/>
    <p:restoredTop sz="94616" autoAdjust="0"/>
  </p:normalViewPr>
  <p:slideViewPr>
    <p:cSldViewPr snapToGrid="0">
      <p:cViewPr varScale="1">
        <p:scale>
          <a:sx n="104" d="100"/>
          <a:sy n="104" d="100"/>
        </p:scale>
        <p:origin x="612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image" Target="../media/image6.emf"/><Relationship Id="rId7" Type="http://schemas.openxmlformats.org/officeDocument/2006/relationships/image" Target="../media/image10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3" Type="http://schemas.openxmlformats.org/officeDocument/2006/relationships/image" Target="../media/image22.emf"/><Relationship Id="rId7" Type="http://schemas.openxmlformats.org/officeDocument/2006/relationships/image" Target="../media/image26.emf"/><Relationship Id="rId2" Type="http://schemas.openxmlformats.org/officeDocument/2006/relationships/image" Target="../media/image21.emf"/><Relationship Id="rId1" Type="http://schemas.openxmlformats.org/officeDocument/2006/relationships/image" Target="../media/image20.emf"/><Relationship Id="rId6" Type="http://schemas.openxmlformats.org/officeDocument/2006/relationships/image" Target="../media/image25.emf"/><Relationship Id="rId5" Type="http://schemas.openxmlformats.org/officeDocument/2006/relationships/image" Target="../media/image24.emf"/><Relationship Id="rId4" Type="http://schemas.openxmlformats.org/officeDocument/2006/relationships/image" Target="../media/image23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35.emf"/><Relationship Id="rId3" Type="http://schemas.openxmlformats.org/officeDocument/2006/relationships/image" Target="../media/image30.emf"/><Relationship Id="rId7" Type="http://schemas.openxmlformats.org/officeDocument/2006/relationships/image" Target="../media/image34.emf"/><Relationship Id="rId2" Type="http://schemas.openxmlformats.org/officeDocument/2006/relationships/image" Target="../media/image29.emf"/><Relationship Id="rId1" Type="http://schemas.openxmlformats.org/officeDocument/2006/relationships/image" Target="../media/image28.emf"/><Relationship Id="rId6" Type="http://schemas.openxmlformats.org/officeDocument/2006/relationships/image" Target="../media/image33.emf"/><Relationship Id="rId5" Type="http://schemas.openxmlformats.org/officeDocument/2006/relationships/image" Target="../media/image32.emf"/><Relationship Id="rId4" Type="http://schemas.openxmlformats.org/officeDocument/2006/relationships/image" Target="../media/image3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E7EE6A-1BBE-4226-8677-115D2C965C91}" type="datetimeFigureOut">
              <a:rPr lang="en-US" smtClean="0"/>
              <a:t>4/28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6300" y="1243013"/>
            <a:ext cx="25146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2BDF94-F63B-4105-A7C5-A89FC9E7F97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95753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B2BDF94-F63B-4105-A7C5-A89FC9E7F97C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00369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ko-KR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AE906-571A-4A10-8FDF-47CE4B8AE94E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AF9F6-7FD0-4A28-B8D3-329B014EC1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719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AE906-571A-4A10-8FDF-47CE4B8AE94E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AF9F6-7FD0-4A28-B8D3-329B014EC1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360243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AE906-571A-4A10-8FDF-47CE4B8AE94E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AF9F6-7FD0-4A28-B8D3-329B014EC1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9717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AE906-571A-4A10-8FDF-47CE4B8AE94E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AF9F6-7FD0-4A28-B8D3-329B014EC1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2331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AE906-571A-4A10-8FDF-47CE4B8AE94E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AF9F6-7FD0-4A28-B8D3-329B014EC1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37440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AE906-571A-4A10-8FDF-47CE4B8AE94E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AF9F6-7FD0-4A28-B8D3-329B014EC1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4145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AE906-571A-4A10-8FDF-47CE4B8AE94E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AF9F6-7FD0-4A28-B8D3-329B014EC1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4002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AE906-571A-4A10-8FDF-47CE4B8AE94E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AF9F6-7FD0-4A28-B8D3-329B014EC1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468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AE906-571A-4A10-8FDF-47CE4B8AE94E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AF9F6-7FD0-4A28-B8D3-329B014EC1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18877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AE906-571A-4A10-8FDF-47CE4B8AE94E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AF9F6-7FD0-4A28-B8D3-329B014EC1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09239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ko-KR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BAE906-571A-4A10-8FDF-47CE4B8AE94E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2AF9F6-7FD0-4A28-B8D3-329B014EC1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3096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 smtClean="0"/>
              <a:t>Click to edit Master text styles</a:t>
            </a:r>
          </a:p>
          <a:p>
            <a:pPr lvl="1"/>
            <a:r>
              <a:rPr lang="en-US" altLang="ko-KR" smtClean="0"/>
              <a:t>Second level</a:t>
            </a:r>
          </a:p>
          <a:p>
            <a:pPr lvl="2"/>
            <a:r>
              <a:rPr lang="en-US" altLang="ko-KR" smtClean="0"/>
              <a:t>Third level</a:t>
            </a:r>
          </a:p>
          <a:p>
            <a:pPr lvl="3"/>
            <a:r>
              <a:rPr lang="en-US" altLang="ko-KR" smtClean="0"/>
              <a:t>Fourth level</a:t>
            </a:r>
          </a:p>
          <a:p>
            <a:pPr lvl="4"/>
            <a:r>
              <a:rPr lang="en-US" altLang="ko-KR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BAE906-571A-4A10-8FDF-47CE4B8AE94E}" type="datetimeFigureOut">
              <a:rPr lang="ko-KR" altLang="en-US" smtClean="0"/>
              <a:t>2020-04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2AF9F6-7FD0-4A28-B8D3-329B014EC19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4849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1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8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0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7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oleObject" Target="../embeddings/oleObject14.bin"/><Relationship Id="rId18" Type="http://schemas.openxmlformats.org/officeDocument/2006/relationships/image" Target="../media/image19.emf"/><Relationship Id="rId3" Type="http://schemas.openxmlformats.org/officeDocument/2006/relationships/oleObject" Target="../embeddings/oleObject9.bin"/><Relationship Id="rId7" Type="http://schemas.openxmlformats.org/officeDocument/2006/relationships/oleObject" Target="../embeddings/oleObject11.bin"/><Relationship Id="rId12" Type="http://schemas.openxmlformats.org/officeDocument/2006/relationships/image" Target="../media/image16.emf"/><Relationship Id="rId17" Type="http://schemas.openxmlformats.org/officeDocument/2006/relationships/oleObject" Target="../embeddings/oleObject16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8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13.emf"/><Relationship Id="rId11" Type="http://schemas.openxmlformats.org/officeDocument/2006/relationships/oleObject" Target="../embeddings/oleObject13.bin"/><Relationship Id="rId5" Type="http://schemas.openxmlformats.org/officeDocument/2006/relationships/oleObject" Target="../embeddings/oleObject10.bin"/><Relationship Id="rId15" Type="http://schemas.openxmlformats.org/officeDocument/2006/relationships/oleObject" Target="../embeddings/oleObject15.bin"/><Relationship Id="rId10" Type="http://schemas.openxmlformats.org/officeDocument/2006/relationships/image" Target="../media/image15.emf"/><Relationship Id="rId4" Type="http://schemas.openxmlformats.org/officeDocument/2006/relationships/image" Target="../media/image12.emf"/><Relationship Id="rId9" Type="http://schemas.openxmlformats.org/officeDocument/2006/relationships/oleObject" Target="../embeddings/oleObject12.bin"/><Relationship Id="rId14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13" Type="http://schemas.openxmlformats.org/officeDocument/2006/relationships/oleObject" Target="../embeddings/oleObject22.bin"/><Relationship Id="rId18" Type="http://schemas.openxmlformats.org/officeDocument/2006/relationships/image" Target="../media/image27.emf"/><Relationship Id="rId3" Type="http://schemas.openxmlformats.org/officeDocument/2006/relationships/oleObject" Target="../embeddings/oleObject17.bin"/><Relationship Id="rId7" Type="http://schemas.openxmlformats.org/officeDocument/2006/relationships/oleObject" Target="../embeddings/oleObject19.bin"/><Relationship Id="rId12" Type="http://schemas.openxmlformats.org/officeDocument/2006/relationships/image" Target="../media/image24.emf"/><Relationship Id="rId17" Type="http://schemas.openxmlformats.org/officeDocument/2006/relationships/oleObject" Target="../embeddings/oleObject24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26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21.emf"/><Relationship Id="rId11" Type="http://schemas.openxmlformats.org/officeDocument/2006/relationships/oleObject" Target="../embeddings/oleObject21.bin"/><Relationship Id="rId5" Type="http://schemas.openxmlformats.org/officeDocument/2006/relationships/oleObject" Target="../embeddings/oleObject18.bin"/><Relationship Id="rId15" Type="http://schemas.openxmlformats.org/officeDocument/2006/relationships/oleObject" Target="../embeddings/oleObject23.bin"/><Relationship Id="rId10" Type="http://schemas.openxmlformats.org/officeDocument/2006/relationships/image" Target="../media/image23.emf"/><Relationship Id="rId4" Type="http://schemas.openxmlformats.org/officeDocument/2006/relationships/image" Target="../media/image20.emf"/><Relationship Id="rId9" Type="http://schemas.openxmlformats.org/officeDocument/2006/relationships/oleObject" Target="../embeddings/oleObject20.bin"/><Relationship Id="rId14" Type="http://schemas.openxmlformats.org/officeDocument/2006/relationships/image" Target="../media/image25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13" Type="http://schemas.openxmlformats.org/officeDocument/2006/relationships/oleObject" Target="../embeddings/oleObject30.bin"/><Relationship Id="rId18" Type="http://schemas.openxmlformats.org/officeDocument/2006/relationships/image" Target="../media/image35.emf"/><Relationship Id="rId3" Type="http://schemas.openxmlformats.org/officeDocument/2006/relationships/oleObject" Target="../embeddings/oleObject25.bin"/><Relationship Id="rId7" Type="http://schemas.openxmlformats.org/officeDocument/2006/relationships/oleObject" Target="../embeddings/oleObject27.bin"/><Relationship Id="rId12" Type="http://schemas.openxmlformats.org/officeDocument/2006/relationships/image" Target="../media/image32.emf"/><Relationship Id="rId17" Type="http://schemas.openxmlformats.org/officeDocument/2006/relationships/oleObject" Target="../embeddings/oleObject32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34.emf"/><Relationship Id="rId1" Type="http://schemas.openxmlformats.org/officeDocument/2006/relationships/vmlDrawing" Target="../drawings/vmlDrawing4.vml"/><Relationship Id="rId6" Type="http://schemas.openxmlformats.org/officeDocument/2006/relationships/image" Target="../media/image29.emf"/><Relationship Id="rId11" Type="http://schemas.openxmlformats.org/officeDocument/2006/relationships/oleObject" Target="../embeddings/oleObject29.bin"/><Relationship Id="rId5" Type="http://schemas.openxmlformats.org/officeDocument/2006/relationships/oleObject" Target="../embeddings/oleObject26.bin"/><Relationship Id="rId15" Type="http://schemas.openxmlformats.org/officeDocument/2006/relationships/oleObject" Target="../embeddings/oleObject31.bin"/><Relationship Id="rId10" Type="http://schemas.openxmlformats.org/officeDocument/2006/relationships/image" Target="../media/image31.emf"/><Relationship Id="rId4" Type="http://schemas.openxmlformats.org/officeDocument/2006/relationships/image" Target="../media/image28.emf"/><Relationship Id="rId9" Type="http://schemas.openxmlformats.org/officeDocument/2006/relationships/oleObject" Target="../embeddings/oleObject28.bin"/><Relationship Id="rId14" Type="http://schemas.openxmlformats.org/officeDocument/2006/relationships/image" Target="../media/image33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5" Type="http://schemas.openxmlformats.org/officeDocument/2006/relationships/image" Target="../media/image38.png"/><Relationship Id="rId4" Type="http://schemas.openxmlformats.org/officeDocument/2006/relationships/image" Target="../media/image37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-63064" y="576427"/>
            <a:ext cx="7003554" cy="2092671"/>
          </a:xfrm>
        </p:spPr>
        <p:txBody>
          <a:bodyPr/>
          <a:lstStyle/>
          <a:p>
            <a:pPr algn="ctr"/>
            <a:r>
              <a:rPr lang="en-US" altLang="ko-KR" b="1" dirty="0" smtClean="0"/>
              <a:t>Supporting information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34762695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Box 61"/>
          <p:cNvSpPr txBox="1"/>
          <p:nvPr/>
        </p:nvSpPr>
        <p:spPr>
          <a:xfrm>
            <a:off x="99294" y="986494"/>
            <a:ext cx="222663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654" y="2423465"/>
            <a:ext cx="316113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280669" y="2423465"/>
            <a:ext cx="316112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559683" y="2423465"/>
            <a:ext cx="316113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190651" y="4581472"/>
            <a:ext cx="6496439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</a:t>
            </a:r>
            <a:r>
              <a:rPr lang="en-US" sz="140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1. </a:t>
            </a:r>
            <a:r>
              <a:rPr lang="en-US" sz="14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Enlarged phenotypic images of BMDM 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infected with </a:t>
            </a:r>
            <a:r>
              <a:rPr lang="en-US" sz="1400" i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. </a:t>
            </a:r>
            <a:r>
              <a:rPr lang="en-US" sz="1400" i="1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mazonensis</a:t>
            </a:r>
            <a:r>
              <a:rPr lang="en-US" sz="14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mastigote with MOI of 1:10 at 96 </a:t>
            </a:r>
            <a:r>
              <a:rPr lang="en-US" sz="140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pi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(A) Draq-5 stained image, (B) </a:t>
            </a:r>
            <a:r>
              <a:rPr lang="en-US" sz="140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Cherry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fluorescent image, and (C) merged image of Draq-5 stained and </a:t>
            </a:r>
            <a:r>
              <a:rPr lang="en-US" sz="140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Cherry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fluorescent images. Inner red dashed line represents the edge of </a:t>
            </a:r>
            <a:r>
              <a:rPr lang="en-US" sz="140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parasitophorous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vacuole and yellow dashed line for the outer edge of host cell cytoplasm. The light blue arrow marks the parasite with both Draq-5 and </a:t>
            </a:r>
            <a:r>
              <a:rPr lang="en-US" sz="140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Cherry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signals, whereas the white arrow marks the parasite with only Draq-5 signal. Scale </a:t>
            </a:r>
            <a:r>
              <a:rPr lang="en-US" sz="14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ar, 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10 </a:t>
            </a:r>
            <a:r>
              <a:rPr lang="en-US" sz="140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μm</a:t>
            </a:r>
            <a:r>
              <a:rPr lang="en-US" sz="14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5" name="Group 24"/>
          <p:cNvGrpSpPr/>
          <p:nvPr/>
        </p:nvGrpSpPr>
        <p:grpSpPr>
          <a:xfrm>
            <a:off x="293391" y="2405055"/>
            <a:ext cx="1980802" cy="1862487"/>
            <a:chOff x="274729" y="2405055"/>
            <a:chExt cx="1980802" cy="1862487"/>
          </a:xfrm>
        </p:grpSpPr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540" t="62112" r="51966" b="32741"/>
            <a:stretch/>
          </p:blipFill>
          <p:spPr>
            <a:xfrm>
              <a:off x="277403" y="2410770"/>
              <a:ext cx="1978128" cy="1853541"/>
            </a:xfrm>
            <a:prstGeom prst="rect">
              <a:avLst/>
            </a:prstGeom>
          </p:spPr>
        </p:pic>
        <p:cxnSp>
          <p:nvCxnSpPr>
            <p:cNvPr id="28" name="Straight Arrow Connector 27"/>
            <p:cNvCxnSpPr/>
            <p:nvPr/>
          </p:nvCxnSpPr>
          <p:spPr>
            <a:xfrm rot="-2400000">
              <a:off x="1412141" y="3514976"/>
              <a:ext cx="288000" cy="0"/>
            </a:xfrm>
            <a:prstGeom prst="straightConnector1">
              <a:avLst/>
            </a:prstGeom>
            <a:ln w="31750">
              <a:solidFill>
                <a:schemeClr val="bg1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/>
            <p:cNvCxnSpPr/>
            <p:nvPr/>
          </p:nvCxnSpPr>
          <p:spPr>
            <a:xfrm rot="4980000">
              <a:off x="777735" y="3171817"/>
              <a:ext cx="288000" cy="0"/>
            </a:xfrm>
            <a:prstGeom prst="straightConnector1">
              <a:avLst/>
            </a:prstGeom>
            <a:ln w="31750">
              <a:solidFill>
                <a:srgbClr val="00B0F0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0" name="Group 29"/>
            <p:cNvGrpSpPr/>
            <p:nvPr/>
          </p:nvGrpSpPr>
          <p:grpSpPr>
            <a:xfrm>
              <a:off x="274729" y="2751640"/>
              <a:ext cx="1799430" cy="1248267"/>
              <a:chOff x="368036" y="2751640"/>
              <a:chExt cx="1799430" cy="1248267"/>
            </a:xfrm>
          </p:grpSpPr>
          <p:sp>
            <p:nvSpPr>
              <p:cNvPr id="46" name="Arc 45"/>
              <p:cNvSpPr/>
              <p:nvPr/>
            </p:nvSpPr>
            <p:spPr>
              <a:xfrm rot="7106204">
                <a:off x="918936" y="2663043"/>
                <a:ext cx="707912" cy="1789148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" name="Arc 46"/>
              <p:cNvSpPr/>
              <p:nvPr/>
            </p:nvSpPr>
            <p:spPr>
              <a:xfrm rot="13523355">
                <a:off x="646293" y="2473383"/>
                <a:ext cx="465740" cy="1022253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" name="Arc 47"/>
              <p:cNvSpPr/>
              <p:nvPr/>
            </p:nvSpPr>
            <p:spPr>
              <a:xfrm rot="20447791" flipV="1">
                <a:off x="1640846" y="2843795"/>
                <a:ext cx="454752" cy="1156112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1" name="Group 30"/>
            <p:cNvGrpSpPr/>
            <p:nvPr/>
          </p:nvGrpSpPr>
          <p:grpSpPr>
            <a:xfrm>
              <a:off x="446495" y="2405055"/>
              <a:ext cx="1756511" cy="1862487"/>
              <a:chOff x="539802" y="2405055"/>
              <a:chExt cx="1756511" cy="1862487"/>
            </a:xfrm>
          </p:grpSpPr>
          <p:sp>
            <p:nvSpPr>
              <p:cNvPr id="32" name="Arc 31"/>
              <p:cNvSpPr/>
              <p:nvPr/>
            </p:nvSpPr>
            <p:spPr>
              <a:xfrm rot="13245973" flipV="1">
                <a:off x="543778" y="2405055"/>
                <a:ext cx="518071" cy="1112839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Arc 32"/>
              <p:cNvSpPr>
                <a:spLocks noChangeAspect="1"/>
              </p:cNvSpPr>
              <p:nvPr/>
            </p:nvSpPr>
            <p:spPr>
              <a:xfrm rot="1134692">
                <a:off x="1980264" y="3266814"/>
                <a:ext cx="316049" cy="814218"/>
              </a:xfrm>
              <a:prstGeom prst="arc">
                <a:avLst>
                  <a:gd name="adj1" fmla="val 16522316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Arc 34"/>
              <p:cNvSpPr/>
              <p:nvPr/>
            </p:nvSpPr>
            <p:spPr>
              <a:xfrm rot="8756668">
                <a:off x="539802" y="3091242"/>
                <a:ext cx="276759" cy="975720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Arc 35"/>
              <p:cNvSpPr>
                <a:spLocks noChangeAspect="1"/>
              </p:cNvSpPr>
              <p:nvPr/>
            </p:nvSpPr>
            <p:spPr>
              <a:xfrm rot="4428200" flipV="1">
                <a:off x="1592655" y="3694641"/>
                <a:ext cx="316049" cy="748614"/>
              </a:xfrm>
              <a:prstGeom prst="arc">
                <a:avLst>
                  <a:gd name="adj1" fmla="val 16522316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4" name="Arc 43"/>
              <p:cNvSpPr>
                <a:spLocks noChangeAspect="1"/>
              </p:cNvSpPr>
              <p:nvPr/>
            </p:nvSpPr>
            <p:spPr>
              <a:xfrm rot="7310834" flipH="1" flipV="1">
                <a:off x="1014981" y="3877130"/>
                <a:ext cx="290035" cy="490790"/>
              </a:xfrm>
              <a:prstGeom prst="arc">
                <a:avLst>
                  <a:gd name="adj1" fmla="val 16522316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5" name="Arc 44"/>
              <p:cNvSpPr>
                <a:spLocks noChangeAspect="1"/>
              </p:cNvSpPr>
              <p:nvPr/>
            </p:nvSpPr>
            <p:spPr>
              <a:xfrm rot="19058596">
                <a:off x="1852367" y="2694831"/>
                <a:ext cx="316049" cy="814218"/>
              </a:xfrm>
              <a:prstGeom prst="arc">
                <a:avLst>
                  <a:gd name="adj1" fmla="val 16522316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49" name="Group 48"/>
          <p:cNvGrpSpPr/>
          <p:nvPr/>
        </p:nvGrpSpPr>
        <p:grpSpPr>
          <a:xfrm>
            <a:off x="2580029" y="2408164"/>
            <a:ext cx="1986844" cy="1862487"/>
            <a:chOff x="2563840" y="2408164"/>
            <a:chExt cx="1986844" cy="1862487"/>
          </a:xfrm>
        </p:grpSpPr>
        <p:pic>
          <p:nvPicPr>
            <p:cNvPr id="50" name="Picture 49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540" t="62047" r="51958" b="32806"/>
            <a:stretch/>
          </p:blipFill>
          <p:spPr>
            <a:xfrm>
              <a:off x="2570016" y="2410767"/>
              <a:ext cx="1980668" cy="1853544"/>
            </a:xfrm>
            <a:prstGeom prst="rect">
              <a:avLst/>
            </a:prstGeom>
          </p:spPr>
        </p:pic>
        <p:cxnSp>
          <p:nvCxnSpPr>
            <p:cNvPr id="51" name="Straight Arrow Connector 50"/>
            <p:cNvCxnSpPr/>
            <p:nvPr/>
          </p:nvCxnSpPr>
          <p:spPr>
            <a:xfrm rot="-2400000">
              <a:off x="3692295" y="3516324"/>
              <a:ext cx="288000" cy="0"/>
            </a:xfrm>
            <a:prstGeom prst="straightConnector1">
              <a:avLst/>
            </a:prstGeom>
            <a:ln w="31750">
              <a:solidFill>
                <a:schemeClr val="bg1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Arrow Connector 53"/>
            <p:cNvCxnSpPr/>
            <p:nvPr/>
          </p:nvCxnSpPr>
          <p:spPr>
            <a:xfrm rot="4980000">
              <a:off x="3057889" y="3173165"/>
              <a:ext cx="288000" cy="0"/>
            </a:xfrm>
            <a:prstGeom prst="straightConnector1">
              <a:avLst/>
            </a:prstGeom>
            <a:ln w="31750">
              <a:solidFill>
                <a:srgbClr val="00B0F0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5" name="Group 54"/>
            <p:cNvGrpSpPr/>
            <p:nvPr/>
          </p:nvGrpSpPr>
          <p:grpSpPr>
            <a:xfrm>
              <a:off x="2563840" y="2754749"/>
              <a:ext cx="1799430" cy="1248267"/>
              <a:chOff x="368036" y="2751640"/>
              <a:chExt cx="1799430" cy="1248267"/>
            </a:xfrm>
          </p:grpSpPr>
          <p:sp>
            <p:nvSpPr>
              <p:cNvPr id="65" name="Arc 64"/>
              <p:cNvSpPr/>
              <p:nvPr/>
            </p:nvSpPr>
            <p:spPr>
              <a:xfrm rot="7106204">
                <a:off x="918936" y="2663043"/>
                <a:ext cx="707912" cy="1789148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6" name="Arc 65"/>
              <p:cNvSpPr/>
              <p:nvPr/>
            </p:nvSpPr>
            <p:spPr>
              <a:xfrm rot="13523355">
                <a:off x="646293" y="2473383"/>
                <a:ext cx="465740" cy="1022253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7" name="Arc 66"/>
              <p:cNvSpPr/>
              <p:nvPr/>
            </p:nvSpPr>
            <p:spPr>
              <a:xfrm rot="20447791" flipV="1">
                <a:off x="1640846" y="2843795"/>
                <a:ext cx="454752" cy="1156112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6" name="Group 55"/>
            <p:cNvGrpSpPr/>
            <p:nvPr/>
          </p:nvGrpSpPr>
          <p:grpSpPr>
            <a:xfrm>
              <a:off x="2735606" y="2408164"/>
              <a:ext cx="1756511" cy="1862487"/>
              <a:chOff x="539802" y="2405055"/>
              <a:chExt cx="1756511" cy="1862487"/>
            </a:xfrm>
          </p:grpSpPr>
          <p:sp>
            <p:nvSpPr>
              <p:cNvPr id="57" name="Arc 56"/>
              <p:cNvSpPr/>
              <p:nvPr/>
            </p:nvSpPr>
            <p:spPr>
              <a:xfrm rot="13245973" flipV="1">
                <a:off x="543778" y="2405055"/>
                <a:ext cx="518071" cy="1112839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8" name="Arc 57"/>
              <p:cNvSpPr>
                <a:spLocks noChangeAspect="1"/>
              </p:cNvSpPr>
              <p:nvPr/>
            </p:nvSpPr>
            <p:spPr>
              <a:xfrm rot="1134692">
                <a:off x="1980264" y="3266814"/>
                <a:ext cx="316049" cy="814218"/>
              </a:xfrm>
              <a:prstGeom prst="arc">
                <a:avLst>
                  <a:gd name="adj1" fmla="val 16522316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" name="Arc 58"/>
              <p:cNvSpPr/>
              <p:nvPr/>
            </p:nvSpPr>
            <p:spPr>
              <a:xfrm rot="8756668">
                <a:off x="539802" y="3091242"/>
                <a:ext cx="276759" cy="975720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" name="Arc 59"/>
              <p:cNvSpPr>
                <a:spLocks noChangeAspect="1"/>
              </p:cNvSpPr>
              <p:nvPr/>
            </p:nvSpPr>
            <p:spPr>
              <a:xfrm rot="4428200" flipV="1">
                <a:off x="1592655" y="3694641"/>
                <a:ext cx="316049" cy="748614"/>
              </a:xfrm>
              <a:prstGeom prst="arc">
                <a:avLst>
                  <a:gd name="adj1" fmla="val 16522316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" name="Arc 60"/>
              <p:cNvSpPr>
                <a:spLocks noChangeAspect="1"/>
              </p:cNvSpPr>
              <p:nvPr/>
            </p:nvSpPr>
            <p:spPr>
              <a:xfrm rot="7310834" flipH="1" flipV="1">
                <a:off x="1014981" y="3877130"/>
                <a:ext cx="290035" cy="490790"/>
              </a:xfrm>
              <a:prstGeom prst="arc">
                <a:avLst>
                  <a:gd name="adj1" fmla="val 16522316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4" name="Arc 63"/>
              <p:cNvSpPr>
                <a:spLocks noChangeAspect="1"/>
              </p:cNvSpPr>
              <p:nvPr/>
            </p:nvSpPr>
            <p:spPr>
              <a:xfrm rot="19058596">
                <a:off x="1852367" y="2694831"/>
                <a:ext cx="316049" cy="814218"/>
              </a:xfrm>
              <a:prstGeom prst="arc">
                <a:avLst>
                  <a:gd name="adj1" fmla="val 16522316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grpSp>
        <p:nvGrpSpPr>
          <p:cNvPr id="68" name="Group 67"/>
          <p:cNvGrpSpPr/>
          <p:nvPr/>
        </p:nvGrpSpPr>
        <p:grpSpPr>
          <a:xfrm>
            <a:off x="4872709" y="2401940"/>
            <a:ext cx="1980627" cy="1862487"/>
            <a:chOff x="4844716" y="2401940"/>
            <a:chExt cx="1980627" cy="1862487"/>
          </a:xfrm>
        </p:grpSpPr>
        <p:pic>
          <p:nvPicPr>
            <p:cNvPr id="69" name="Picture 68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529" t="62142" r="51971" b="32711"/>
            <a:stretch/>
          </p:blipFill>
          <p:spPr>
            <a:xfrm>
              <a:off x="4844716" y="2410770"/>
              <a:ext cx="1980627" cy="1853541"/>
            </a:xfrm>
            <a:prstGeom prst="rect">
              <a:avLst/>
            </a:prstGeom>
          </p:spPr>
        </p:pic>
        <p:cxnSp>
          <p:nvCxnSpPr>
            <p:cNvPr id="70" name="Straight Connector 69"/>
            <p:cNvCxnSpPr>
              <a:cxnSpLocks noChangeAspect="1"/>
            </p:cNvCxnSpPr>
            <p:nvPr/>
          </p:nvCxnSpPr>
          <p:spPr>
            <a:xfrm>
              <a:off x="6316153" y="4181761"/>
              <a:ext cx="4392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Arrow Connector 70"/>
            <p:cNvCxnSpPr/>
            <p:nvPr/>
          </p:nvCxnSpPr>
          <p:spPr>
            <a:xfrm rot="-2400000">
              <a:off x="5987068" y="3497444"/>
              <a:ext cx="288000" cy="0"/>
            </a:xfrm>
            <a:prstGeom prst="straightConnector1">
              <a:avLst/>
            </a:prstGeom>
            <a:ln w="31750">
              <a:solidFill>
                <a:schemeClr val="bg1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Arrow Connector 71"/>
            <p:cNvCxnSpPr/>
            <p:nvPr/>
          </p:nvCxnSpPr>
          <p:spPr>
            <a:xfrm rot="4980000">
              <a:off x="5352662" y="3154285"/>
              <a:ext cx="288000" cy="0"/>
            </a:xfrm>
            <a:prstGeom prst="straightConnector1">
              <a:avLst/>
            </a:prstGeom>
            <a:ln w="31750">
              <a:solidFill>
                <a:srgbClr val="00B0F0"/>
              </a:solidFill>
              <a:tailEnd type="triangl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3" name="Group 72"/>
            <p:cNvGrpSpPr/>
            <p:nvPr/>
          </p:nvGrpSpPr>
          <p:grpSpPr>
            <a:xfrm>
              <a:off x="4852949" y="2748525"/>
              <a:ext cx="1799430" cy="1248267"/>
              <a:chOff x="368036" y="2751640"/>
              <a:chExt cx="1799430" cy="1248267"/>
            </a:xfrm>
          </p:grpSpPr>
          <p:sp>
            <p:nvSpPr>
              <p:cNvPr id="82" name="Arc 81"/>
              <p:cNvSpPr/>
              <p:nvPr/>
            </p:nvSpPr>
            <p:spPr>
              <a:xfrm rot="7106204">
                <a:off x="918936" y="2663043"/>
                <a:ext cx="707912" cy="1789148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3" name="Arc 82"/>
              <p:cNvSpPr/>
              <p:nvPr/>
            </p:nvSpPr>
            <p:spPr>
              <a:xfrm rot="13523355">
                <a:off x="646293" y="2473383"/>
                <a:ext cx="465740" cy="1022253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4" name="Arc 83"/>
              <p:cNvSpPr/>
              <p:nvPr/>
            </p:nvSpPr>
            <p:spPr>
              <a:xfrm rot="20447791" flipV="1">
                <a:off x="1640846" y="2843795"/>
                <a:ext cx="454752" cy="1156112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4" name="Group 73"/>
            <p:cNvGrpSpPr/>
            <p:nvPr/>
          </p:nvGrpSpPr>
          <p:grpSpPr>
            <a:xfrm>
              <a:off x="5024715" y="2401940"/>
              <a:ext cx="1756511" cy="1862487"/>
              <a:chOff x="539802" y="2405055"/>
              <a:chExt cx="1756511" cy="1862487"/>
            </a:xfrm>
          </p:grpSpPr>
          <p:sp>
            <p:nvSpPr>
              <p:cNvPr id="75" name="Arc 74"/>
              <p:cNvSpPr/>
              <p:nvPr/>
            </p:nvSpPr>
            <p:spPr>
              <a:xfrm rot="13245973" flipV="1">
                <a:off x="543778" y="2405055"/>
                <a:ext cx="518071" cy="1112839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6" name="Arc 75"/>
              <p:cNvSpPr>
                <a:spLocks noChangeAspect="1"/>
              </p:cNvSpPr>
              <p:nvPr/>
            </p:nvSpPr>
            <p:spPr>
              <a:xfrm rot="1134692">
                <a:off x="1980264" y="3266814"/>
                <a:ext cx="316049" cy="814218"/>
              </a:xfrm>
              <a:prstGeom prst="arc">
                <a:avLst>
                  <a:gd name="adj1" fmla="val 16522316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7" name="Arc 76"/>
              <p:cNvSpPr/>
              <p:nvPr/>
            </p:nvSpPr>
            <p:spPr>
              <a:xfrm rot="8756668">
                <a:off x="539802" y="3091242"/>
                <a:ext cx="276759" cy="975720"/>
              </a:xfrm>
              <a:prstGeom prst="arc">
                <a:avLst>
                  <a:gd name="adj1" fmla="val 16248418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78" name="Arc 77"/>
              <p:cNvSpPr>
                <a:spLocks noChangeAspect="1"/>
              </p:cNvSpPr>
              <p:nvPr/>
            </p:nvSpPr>
            <p:spPr>
              <a:xfrm rot="4428200" flipV="1">
                <a:off x="1592655" y="3694641"/>
                <a:ext cx="316049" cy="748614"/>
              </a:xfrm>
              <a:prstGeom prst="arc">
                <a:avLst>
                  <a:gd name="adj1" fmla="val 16522316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0" name="Arc 79"/>
              <p:cNvSpPr>
                <a:spLocks noChangeAspect="1"/>
              </p:cNvSpPr>
              <p:nvPr/>
            </p:nvSpPr>
            <p:spPr>
              <a:xfrm rot="7310834" flipH="1" flipV="1">
                <a:off x="1014981" y="3877130"/>
                <a:ext cx="290035" cy="490790"/>
              </a:xfrm>
              <a:prstGeom prst="arc">
                <a:avLst>
                  <a:gd name="adj1" fmla="val 16522316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1" name="Arc 80"/>
              <p:cNvSpPr>
                <a:spLocks noChangeAspect="1"/>
              </p:cNvSpPr>
              <p:nvPr/>
            </p:nvSpPr>
            <p:spPr>
              <a:xfrm rot="19058596">
                <a:off x="1852367" y="2694831"/>
                <a:ext cx="316049" cy="814218"/>
              </a:xfrm>
              <a:prstGeom prst="arc">
                <a:avLst>
                  <a:gd name="adj1" fmla="val 16522316"/>
                  <a:gd name="adj2" fmla="val 4767652"/>
                </a:avLst>
              </a:prstGeom>
              <a:ln w="28575">
                <a:solidFill>
                  <a:srgbClr val="FFFF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6347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5" name="Object 34"/>
          <p:cNvGraphicFramePr>
            <a:graphicFrameLocks noChangeAspect="1"/>
          </p:cNvGraphicFramePr>
          <p:nvPr>
            <p:extLst/>
          </p:nvPr>
        </p:nvGraphicFramePr>
        <p:xfrm>
          <a:off x="3522481" y="1759228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30" name="Prism 6" r:id="rId3" imgW="4976355" imgH="2177131" progId="Prism6.Document">
                  <p:embed/>
                </p:oleObj>
              </mc:Choice>
              <mc:Fallback>
                <p:oleObj name="Prism 6" r:id="rId3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22481" y="1759228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ct 35"/>
          <p:cNvGraphicFramePr>
            <a:graphicFrameLocks noChangeAspect="1"/>
          </p:cNvGraphicFramePr>
          <p:nvPr>
            <p:extLst/>
          </p:nvPr>
        </p:nvGraphicFramePr>
        <p:xfrm>
          <a:off x="3522481" y="3180407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31" name="Prism 6" r:id="rId5" imgW="4976355" imgH="2177131" progId="Prism6.Document">
                  <p:embed/>
                </p:oleObj>
              </mc:Choice>
              <mc:Fallback>
                <p:oleObj name="Prism 6" r:id="rId5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22481" y="3180407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ct 36"/>
          <p:cNvGraphicFramePr>
            <a:graphicFrameLocks noChangeAspect="1"/>
          </p:cNvGraphicFramePr>
          <p:nvPr>
            <p:extLst/>
          </p:nvPr>
        </p:nvGraphicFramePr>
        <p:xfrm>
          <a:off x="3522481" y="4601586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32" name="Prism 6" r:id="rId7" imgW="4976355" imgH="2177131" progId="Prism6.Document">
                  <p:embed/>
                </p:oleObj>
              </mc:Choice>
              <mc:Fallback>
                <p:oleObj name="Prism 6" r:id="rId7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22481" y="4601586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/>
          <p:cNvGraphicFramePr>
            <a:graphicFrameLocks noChangeAspect="1"/>
          </p:cNvGraphicFramePr>
          <p:nvPr>
            <p:extLst/>
          </p:nvPr>
        </p:nvGraphicFramePr>
        <p:xfrm>
          <a:off x="3522481" y="6022765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33" name="Prism 6" r:id="rId9" imgW="4976355" imgH="2177131" progId="Prism6.Document">
                  <p:embed/>
                </p:oleObj>
              </mc:Choice>
              <mc:Fallback>
                <p:oleObj name="Prism 6" r:id="rId9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22481" y="6022765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ct 32"/>
          <p:cNvGraphicFramePr>
            <a:graphicFrameLocks noChangeAspect="1"/>
          </p:cNvGraphicFramePr>
          <p:nvPr>
            <p:extLst/>
          </p:nvPr>
        </p:nvGraphicFramePr>
        <p:xfrm>
          <a:off x="768153" y="6022765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34" name="Prism 6" r:id="rId11" imgW="4976355" imgH="2177131" progId="Prism6.Document">
                  <p:embed/>
                </p:oleObj>
              </mc:Choice>
              <mc:Fallback>
                <p:oleObj name="Prism 6" r:id="rId11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68153" y="6022765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/>
          <p:cNvGraphicFramePr>
            <a:graphicFrameLocks noChangeAspect="1"/>
          </p:cNvGraphicFramePr>
          <p:nvPr>
            <p:extLst/>
          </p:nvPr>
        </p:nvGraphicFramePr>
        <p:xfrm>
          <a:off x="768153" y="1759228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35" name="Prism 6" r:id="rId13" imgW="4976355" imgH="2177131" progId="Prism6.Document">
                  <p:embed/>
                </p:oleObj>
              </mc:Choice>
              <mc:Fallback>
                <p:oleObj name="Prism 6" r:id="rId13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768153" y="1759228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/>
          <p:cNvGraphicFramePr>
            <a:graphicFrameLocks noChangeAspect="1"/>
          </p:cNvGraphicFramePr>
          <p:nvPr>
            <p:extLst/>
          </p:nvPr>
        </p:nvGraphicFramePr>
        <p:xfrm>
          <a:off x="768153" y="3180407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36" name="Prism 6" r:id="rId15" imgW="4976355" imgH="2177131" progId="Prism6.Document">
                  <p:embed/>
                </p:oleObj>
              </mc:Choice>
              <mc:Fallback>
                <p:oleObj name="Prism 6" r:id="rId15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768153" y="3180407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/>
          <p:cNvGraphicFramePr>
            <a:graphicFrameLocks noChangeAspect="1"/>
          </p:cNvGraphicFramePr>
          <p:nvPr>
            <p:extLst/>
          </p:nvPr>
        </p:nvGraphicFramePr>
        <p:xfrm>
          <a:off x="768153" y="4601586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937" name="Prism 6" r:id="rId17" imgW="4976355" imgH="2177131" progId="Prism6.Document">
                  <p:embed/>
                </p:oleObj>
              </mc:Choice>
              <mc:Fallback>
                <p:oleObj name="Prism 6" r:id="rId17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768153" y="4601586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34848" y="1544027"/>
            <a:ext cx="316113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88131" y="1544027"/>
            <a:ext cx="316112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98031" y="2266685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6200000">
            <a:off x="100491" y="3672058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2851313" y="2269145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2853774" y="3674518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37310" y="2959242"/>
            <a:ext cx="316113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290593" y="2959242"/>
            <a:ext cx="316112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90715" y="5077431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93175" y="6482805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2843997" y="5079891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2846458" y="6485265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32342" y="4374457"/>
            <a:ext cx="306494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291235" y="4374457"/>
            <a:ext cx="295274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25185" y="5789671"/>
            <a:ext cx="325731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283278" y="5789671"/>
            <a:ext cx="316112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89331" y="5961940"/>
            <a:ext cx="338554" cy="13015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444277" y="5965595"/>
            <a:ext cx="338554" cy="13015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89331" y="1676336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689331" y="3104870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89331" y="4511458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444277" y="1679990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444277" y="3108526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444277" y="4515113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044559" y="2786103"/>
            <a:ext cx="872355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>
                <a:latin typeface="Arial" panose="020B0604020202020204" pitchFamily="34" charset="0"/>
                <a:cs typeface="Arial" panose="020B0604020202020204" pitchFamily="34" charset="0"/>
              </a:rPr>
              <a:t>AmpB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075015" y="4187419"/>
            <a:ext cx="811441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>
                <a:latin typeface="Arial" panose="020B0604020202020204" pitchFamily="34" charset="0"/>
                <a:cs typeface="Arial" panose="020B0604020202020204" pitchFamily="34" charset="0"/>
              </a:rPr>
              <a:t>Milte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083029" y="5588736"/>
            <a:ext cx="795411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SSG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4008492" y="7072112"/>
            <a:ext cx="94448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omo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281103" y="2786103"/>
            <a:ext cx="898003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pB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328387" y="4187419"/>
            <a:ext cx="803426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lte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336406" y="5588736"/>
            <a:ext cx="787395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SSG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261865" y="7072112"/>
            <a:ext cx="936475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omo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99294" y="986494"/>
            <a:ext cx="222663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190651" y="7470498"/>
            <a:ext cx="6496439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</a:t>
            </a:r>
            <a:r>
              <a:rPr lang="en-US" sz="140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2. </a:t>
            </a:r>
            <a:r>
              <a:rPr lang="en-US" sz="14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ose-response curves (DRCs) of reference drugs 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rom </a:t>
            </a:r>
            <a:r>
              <a:rPr lang="en-US" sz="1400" i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</a:t>
            </a:r>
            <a:r>
              <a:rPr lang="en-US" sz="1400" i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</a:t>
            </a:r>
            <a:r>
              <a:rPr lang="en-US" sz="1400" i="1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mazonensis</a:t>
            </a:r>
            <a:r>
              <a:rPr lang="en-US" sz="14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infected 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MDM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C of (A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C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tefosin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E) SSG, and (G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omomyci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osures to BMDM infected with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azonensis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astigotes. DRC of (B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D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tefosin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F) SSG, and (H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omomyci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osures to BMDM infected with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azonensis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astigotes. Results represent the values with standard deviations from duplicate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ements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11526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38935065"/>
              </p:ext>
            </p:extLst>
          </p:nvPr>
        </p:nvGraphicFramePr>
        <p:xfrm>
          <a:off x="3517511" y="1745894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10" name="Prism 6" r:id="rId3" imgW="4976355" imgH="2177131" progId="Prism6.Document">
                  <p:embed/>
                </p:oleObj>
              </mc:Choice>
              <mc:Fallback>
                <p:oleObj name="Prism 6" r:id="rId3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17511" y="1745894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0677277"/>
              </p:ext>
            </p:extLst>
          </p:nvPr>
        </p:nvGraphicFramePr>
        <p:xfrm>
          <a:off x="3517511" y="3160180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11" name="Prism 6" r:id="rId5" imgW="4976355" imgH="2177131" progId="Prism6.Document">
                  <p:embed/>
                </p:oleObj>
              </mc:Choice>
              <mc:Fallback>
                <p:oleObj name="Prism 6" r:id="rId5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17511" y="3160180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5135699"/>
              </p:ext>
            </p:extLst>
          </p:nvPr>
        </p:nvGraphicFramePr>
        <p:xfrm>
          <a:off x="3517511" y="4574466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12" name="Prism 6" r:id="rId7" imgW="4976355" imgH="2177131" progId="Prism6.Document">
                  <p:embed/>
                </p:oleObj>
              </mc:Choice>
              <mc:Fallback>
                <p:oleObj name="Prism 6" r:id="rId7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17511" y="4574466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4754932"/>
              </p:ext>
            </p:extLst>
          </p:nvPr>
        </p:nvGraphicFramePr>
        <p:xfrm>
          <a:off x="3517511" y="5988751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13" name="Prism 6" r:id="rId9" imgW="4976355" imgH="2177131" progId="Prism6.Document">
                  <p:embed/>
                </p:oleObj>
              </mc:Choice>
              <mc:Fallback>
                <p:oleObj name="Prism 6" r:id="rId9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17511" y="5988751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2963806"/>
              </p:ext>
            </p:extLst>
          </p:nvPr>
        </p:nvGraphicFramePr>
        <p:xfrm>
          <a:off x="752840" y="1745894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14" name="Prism 6" r:id="rId11" imgW="4976355" imgH="2177131" progId="Prism6.Document">
                  <p:embed/>
                </p:oleObj>
              </mc:Choice>
              <mc:Fallback>
                <p:oleObj name="Prism 6" r:id="rId11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52840" y="1745894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479523"/>
              </p:ext>
            </p:extLst>
          </p:nvPr>
        </p:nvGraphicFramePr>
        <p:xfrm>
          <a:off x="752840" y="3160180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15" name="Prism 6" r:id="rId13" imgW="4976355" imgH="2177131" progId="Prism6.Document">
                  <p:embed/>
                </p:oleObj>
              </mc:Choice>
              <mc:Fallback>
                <p:oleObj name="Prism 6" r:id="rId13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752840" y="3160180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1546363"/>
              </p:ext>
            </p:extLst>
          </p:nvPr>
        </p:nvGraphicFramePr>
        <p:xfrm>
          <a:off x="752840" y="4574466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16" name="Prism 6" r:id="rId15" imgW="4976355" imgH="2177131" progId="Prism6.Document">
                  <p:embed/>
                </p:oleObj>
              </mc:Choice>
              <mc:Fallback>
                <p:oleObj name="Prism 6" r:id="rId15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752840" y="4574466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1873515"/>
              </p:ext>
            </p:extLst>
          </p:nvPr>
        </p:nvGraphicFramePr>
        <p:xfrm>
          <a:off x="752840" y="5988751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417" name="Prism 6" r:id="rId17" imgW="4976355" imgH="2177131" progId="Prism6.Document">
                  <p:embed/>
                </p:oleObj>
              </mc:Choice>
              <mc:Fallback>
                <p:oleObj name="Prism 6" r:id="rId17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752840" y="5988751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534848" y="1543878"/>
            <a:ext cx="316113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288131" y="1543878"/>
            <a:ext cx="316112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98031" y="2266536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100491" y="3671909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2851313" y="2268996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2853774" y="3674369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37310" y="2959093"/>
            <a:ext cx="316113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290593" y="2959093"/>
            <a:ext cx="316112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90715" y="5077282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93175" y="6482656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2843997" y="5079742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2846458" y="6485116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32342" y="4374308"/>
            <a:ext cx="306494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291235" y="4374308"/>
            <a:ext cx="295274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25185" y="5789522"/>
            <a:ext cx="325731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283278" y="5789522"/>
            <a:ext cx="316112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58872" y="3148615"/>
            <a:ext cx="369012" cy="12722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10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658872" y="4547887"/>
            <a:ext cx="369012" cy="12722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10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413819" y="3152270"/>
            <a:ext cx="369012" cy="12722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10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413819" y="4547887"/>
            <a:ext cx="369012" cy="12722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10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689331" y="1676187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689331" y="5925212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444277" y="1679841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444277" y="5928867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99294" y="986494"/>
            <a:ext cx="222663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044559" y="2774380"/>
            <a:ext cx="872355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>
                <a:latin typeface="Arial" panose="020B0604020202020204" pitchFamily="34" charset="0"/>
                <a:cs typeface="Arial" panose="020B0604020202020204" pitchFamily="34" charset="0"/>
              </a:rPr>
              <a:t>AmpB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075015" y="4175696"/>
            <a:ext cx="811441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>
                <a:latin typeface="Arial" panose="020B0604020202020204" pitchFamily="34" charset="0"/>
                <a:cs typeface="Arial" panose="020B0604020202020204" pitchFamily="34" charset="0"/>
              </a:rPr>
              <a:t>Milte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083029" y="5577013"/>
            <a:ext cx="795411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SSG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4008492" y="6978328"/>
            <a:ext cx="94448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omo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281103" y="2774380"/>
            <a:ext cx="898003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pB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328387" y="4175696"/>
            <a:ext cx="803426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lte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336406" y="5577013"/>
            <a:ext cx="787395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SSG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261865" y="6978328"/>
            <a:ext cx="936475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omo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190651" y="7470498"/>
            <a:ext cx="649643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</a:t>
            </a:r>
            <a:r>
              <a:rPr lang="en-US" sz="140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3. </a:t>
            </a:r>
            <a:r>
              <a:rPr lang="en-US" sz="14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ose-response curves (DRCs) of reference drugs 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rom </a:t>
            </a:r>
            <a:r>
              <a:rPr lang="en-US" sz="1400" i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. </a:t>
            </a:r>
            <a:r>
              <a:rPr lang="en-US" sz="1400" i="1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onovani</a:t>
            </a:r>
            <a:r>
              <a:rPr lang="en-US" sz="14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infected 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MDM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C of (A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C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tefosin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E) SSG, and (G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omomyci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osures to BMDM infected with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novani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astigotes. DRC of (B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D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tefosin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F) SSG, and (H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omomyci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osures to BMDM infected with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novani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astigotes. Results represent the values with standard deviations from duplicate measurement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79265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16040040"/>
              </p:ext>
            </p:extLst>
          </p:nvPr>
        </p:nvGraphicFramePr>
        <p:xfrm>
          <a:off x="3511099" y="1745818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946" name="Prism 6" r:id="rId3" imgW="4976355" imgH="2177131" progId="Prism6.Document">
                  <p:embed/>
                </p:oleObj>
              </mc:Choice>
              <mc:Fallback>
                <p:oleObj name="Prism 6" r:id="rId3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11099" y="1745818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4391595"/>
              </p:ext>
            </p:extLst>
          </p:nvPr>
        </p:nvGraphicFramePr>
        <p:xfrm>
          <a:off x="3511099" y="3156985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947" name="Prism 6" r:id="rId5" imgW="4976355" imgH="2177131" progId="Prism6.Document">
                  <p:embed/>
                </p:oleObj>
              </mc:Choice>
              <mc:Fallback>
                <p:oleObj name="Prism 6" r:id="rId5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11099" y="3156985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5822516"/>
              </p:ext>
            </p:extLst>
          </p:nvPr>
        </p:nvGraphicFramePr>
        <p:xfrm>
          <a:off x="3511099" y="4568152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948" name="Prism 6" r:id="rId7" imgW="4976355" imgH="2177131" progId="Prism6.Document">
                  <p:embed/>
                </p:oleObj>
              </mc:Choice>
              <mc:Fallback>
                <p:oleObj name="Prism 6" r:id="rId7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11099" y="4568152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2808915"/>
              </p:ext>
            </p:extLst>
          </p:nvPr>
        </p:nvGraphicFramePr>
        <p:xfrm>
          <a:off x="3511099" y="5979318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949" name="Prism 6" r:id="rId9" imgW="4976355" imgH="2177131" progId="Prism6.Document">
                  <p:embed/>
                </p:oleObj>
              </mc:Choice>
              <mc:Fallback>
                <p:oleObj name="Prism 6" r:id="rId9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11099" y="5979318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039194"/>
              </p:ext>
            </p:extLst>
          </p:nvPr>
        </p:nvGraphicFramePr>
        <p:xfrm>
          <a:off x="763226" y="1745818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950" name="Prism 6" r:id="rId11" imgW="4976355" imgH="2177131" progId="Prism6.Document">
                  <p:embed/>
                </p:oleObj>
              </mc:Choice>
              <mc:Fallback>
                <p:oleObj name="Prism 6" r:id="rId11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763226" y="1745818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8802174"/>
              </p:ext>
            </p:extLst>
          </p:nvPr>
        </p:nvGraphicFramePr>
        <p:xfrm>
          <a:off x="763226" y="3156985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951" name="Prism 6" r:id="rId13" imgW="4976355" imgH="2177131" progId="Prism6.Document">
                  <p:embed/>
                </p:oleObj>
              </mc:Choice>
              <mc:Fallback>
                <p:oleObj name="Prism 6" r:id="rId13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763226" y="3156985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5725191"/>
              </p:ext>
            </p:extLst>
          </p:nvPr>
        </p:nvGraphicFramePr>
        <p:xfrm>
          <a:off x="763226" y="4568152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952" name="Prism 6" r:id="rId15" imgW="4976355" imgH="2177131" progId="Prism6.Document">
                  <p:embed/>
                </p:oleObj>
              </mc:Choice>
              <mc:Fallback>
                <p:oleObj name="Prism 6" r:id="rId15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763226" y="4568152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6780383"/>
              </p:ext>
            </p:extLst>
          </p:nvPr>
        </p:nvGraphicFramePr>
        <p:xfrm>
          <a:off x="763226" y="5979318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953" name="Prism 6" r:id="rId17" imgW="4976355" imgH="2177131" progId="Prism6.Document">
                  <p:embed/>
                </p:oleObj>
              </mc:Choice>
              <mc:Fallback>
                <p:oleObj name="Prism 6" r:id="rId17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763226" y="5979318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534848" y="1542964"/>
            <a:ext cx="316113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288131" y="1542964"/>
            <a:ext cx="316112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98031" y="2265622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100491" y="3670995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2851313" y="2268082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2853774" y="3673455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37310" y="2958179"/>
            <a:ext cx="316113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290593" y="2958179"/>
            <a:ext cx="316112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90715" y="5076368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93175" y="6481742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2843997" y="5078828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2846458" y="6484202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32342" y="4373394"/>
            <a:ext cx="306494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291235" y="4373394"/>
            <a:ext cx="295274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25185" y="5788608"/>
            <a:ext cx="325731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283278" y="5788608"/>
            <a:ext cx="316112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89331" y="1675273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89331" y="3103807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89331" y="4510395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89331" y="5924298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444277" y="1678927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444277" y="3107463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444277" y="4514050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444277" y="5927953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99294" y="986494"/>
            <a:ext cx="222663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4032836" y="2774380"/>
            <a:ext cx="872355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>
                <a:latin typeface="Arial" panose="020B0604020202020204" pitchFamily="34" charset="0"/>
                <a:cs typeface="Arial" panose="020B0604020202020204" pitchFamily="34" charset="0"/>
              </a:rPr>
              <a:t>AmpB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063292" y="4175696"/>
            <a:ext cx="811441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>
                <a:latin typeface="Arial" panose="020B0604020202020204" pitchFamily="34" charset="0"/>
                <a:cs typeface="Arial" panose="020B0604020202020204" pitchFamily="34" charset="0"/>
              </a:rPr>
              <a:t>Milte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071306" y="5577013"/>
            <a:ext cx="795411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SSG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996769" y="6978328"/>
            <a:ext cx="94448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omo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1269380" y="2774380"/>
            <a:ext cx="898003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pB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1316664" y="4175696"/>
            <a:ext cx="803426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lte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324683" y="5577013"/>
            <a:ext cx="787395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SSG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250142" y="6978328"/>
            <a:ext cx="936475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omo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190651" y="7470498"/>
            <a:ext cx="649643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</a:t>
            </a:r>
            <a:r>
              <a:rPr lang="en-US" sz="140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4. </a:t>
            </a:r>
            <a:r>
              <a:rPr lang="en-US" sz="14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ose-response curves (DRCs) of reference drugs 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rom </a:t>
            </a:r>
            <a:r>
              <a:rPr lang="en-US" sz="1400" i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. </a:t>
            </a:r>
            <a:r>
              <a:rPr lang="en-US" sz="1400" i="1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mazonensis</a:t>
            </a:r>
            <a:r>
              <a:rPr lang="en-US" sz="14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infected THP-1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C of (A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C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tefosin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E) SSG, and (G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omomyci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osures to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P-1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ected with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azonensis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astigotes. DRC of (B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D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tefosin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F) SSG, and (H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omomyci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osures to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P-1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ected with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azonensis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astigotes. Results represent the values with standard deviations from duplicate measurement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86302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1698499"/>
              </p:ext>
            </p:extLst>
          </p:nvPr>
        </p:nvGraphicFramePr>
        <p:xfrm>
          <a:off x="752895" y="1744690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458" name="Prism 6" r:id="rId3" imgW="4976355" imgH="2177131" progId="Prism6.Document">
                  <p:embed/>
                </p:oleObj>
              </mc:Choice>
              <mc:Fallback>
                <p:oleObj name="Prism 6" r:id="rId3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52895" y="1744690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8740875"/>
              </p:ext>
            </p:extLst>
          </p:nvPr>
        </p:nvGraphicFramePr>
        <p:xfrm>
          <a:off x="752895" y="3158532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459" name="Prism 6" r:id="rId5" imgW="4976355" imgH="2177131" progId="Prism6.Document">
                  <p:embed/>
                </p:oleObj>
              </mc:Choice>
              <mc:Fallback>
                <p:oleObj name="Prism 6" r:id="rId5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52895" y="3158532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5372018"/>
              </p:ext>
            </p:extLst>
          </p:nvPr>
        </p:nvGraphicFramePr>
        <p:xfrm>
          <a:off x="752895" y="4572374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460" name="Prism 6" r:id="rId7" imgW="4976355" imgH="2177131" progId="Prism6.Document">
                  <p:embed/>
                </p:oleObj>
              </mc:Choice>
              <mc:Fallback>
                <p:oleObj name="Prism 6" r:id="rId7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52895" y="4572374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5559641"/>
              </p:ext>
            </p:extLst>
          </p:nvPr>
        </p:nvGraphicFramePr>
        <p:xfrm>
          <a:off x="752895" y="5986217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461" name="Prism 6" r:id="rId9" imgW="4976355" imgH="2177131" progId="Prism6.Document">
                  <p:embed/>
                </p:oleObj>
              </mc:Choice>
              <mc:Fallback>
                <p:oleObj name="Prism 6" r:id="rId9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52895" y="5986217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63908352"/>
              </p:ext>
            </p:extLst>
          </p:nvPr>
        </p:nvGraphicFramePr>
        <p:xfrm>
          <a:off x="3518928" y="3158532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462" name="Prism 6" r:id="rId11" imgW="4976355" imgH="2177131" progId="Prism6.Document">
                  <p:embed/>
                </p:oleObj>
              </mc:Choice>
              <mc:Fallback>
                <p:oleObj name="Prism 6" r:id="rId11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518928" y="3158532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7956720"/>
              </p:ext>
            </p:extLst>
          </p:nvPr>
        </p:nvGraphicFramePr>
        <p:xfrm>
          <a:off x="3518928" y="4572374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463" name="Prism 6" r:id="rId13" imgW="4976355" imgH="2177131" progId="Prism6.Document">
                  <p:embed/>
                </p:oleObj>
              </mc:Choice>
              <mc:Fallback>
                <p:oleObj name="Prism 6" r:id="rId13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518928" y="4572374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403130"/>
              </p:ext>
            </p:extLst>
          </p:nvPr>
        </p:nvGraphicFramePr>
        <p:xfrm>
          <a:off x="3518928" y="5986217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464" name="Prism 6" r:id="rId15" imgW="4976355" imgH="2177131" progId="Prism6.Document">
                  <p:embed/>
                </p:oleObj>
              </mc:Choice>
              <mc:Fallback>
                <p:oleObj name="Prism 6" r:id="rId15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518928" y="5986217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8212724"/>
              </p:ext>
            </p:extLst>
          </p:nvPr>
        </p:nvGraphicFramePr>
        <p:xfrm>
          <a:off x="3518928" y="1744690"/>
          <a:ext cx="2687232" cy="1175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465" name="Prism 6" r:id="rId17" imgW="4976355" imgH="2177131" progId="Prism6.Document">
                  <p:embed/>
                </p:oleObj>
              </mc:Choice>
              <mc:Fallback>
                <p:oleObj name="Prism 6" r:id="rId17" imgW="4976355" imgH="217713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518928" y="1744690"/>
                        <a:ext cx="2687232" cy="11756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534849" y="1541290"/>
            <a:ext cx="316113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288132" y="1541290"/>
            <a:ext cx="316112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98032" y="2263948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100492" y="3669321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2851314" y="2266408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2853775" y="3671781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37311" y="2956505"/>
            <a:ext cx="316113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290594" y="2956505"/>
            <a:ext cx="316112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90716" y="5074694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93176" y="6480068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2843998" y="5077154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6200000">
            <a:off x="2846459" y="6482528"/>
            <a:ext cx="118974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Normalized activity (%)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32343" y="4371720"/>
            <a:ext cx="306494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291236" y="4371720"/>
            <a:ext cx="295274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25186" y="5786934"/>
            <a:ext cx="325731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283279" y="5786934"/>
            <a:ext cx="316112" cy="310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21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1421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689332" y="1673599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89332" y="3102133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689332" y="4508721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658873" y="5959202"/>
            <a:ext cx="369012" cy="12722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10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444278" y="1677253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444278" y="3105789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3444278" y="4512376"/>
            <a:ext cx="338554" cy="13433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229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413820" y="5962858"/>
            <a:ext cx="369012" cy="127227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50</a:t>
            </a:r>
          </a:p>
          <a:p>
            <a:pPr algn="r">
              <a:lnSpc>
                <a:spcPct val="180000"/>
              </a:lnSpc>
            </a:pP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-100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99294" y="986494"/>
            <a:ext cx="222663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ko-K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032836" y="2774380"/>
            <a:ext cx="872355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>
                <a:latin typeface="Arial" panose="020B0604020202020204" pitchFamily="34" charset="0"/>
                <a:cs typeface="Arial" panose="020B0604020202020204" pitchFamily="34" charset="0"/>
              </a:rPr>
              <a:t>AmpB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063292" y="4175696"/>
            <a:ext cx="811441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>
                <a:latin typeface="Arial" panose="020B0604020202020204" pitchFamily="34" charset="0"/>
                <a:cs typeface="Arial" panose="020B0604020202020204" pitchFamily="34" charset="0"/>
              </a:rPr>
              <a:t>Milte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071306" y="5577013"/>
            <a:ext cx="795411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SSG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996769" y="6978328"/>
            <a:ext cx="944489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omo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269380" y="2774380"/>
            <a:ext cx="898003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pB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316664" y="4175696"/>
            <a:ext cx="803426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lte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324683" y="5577013"/>
            <a:ext cx="787395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SSG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, 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250142" y="6978328"/>
            <a:ext cx="936475" cy="2015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altLang="ko-KR" sz="71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10 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[</a:t>
            </a:r>
            <a:r>
              <a:rPr lang="en-US" altLang="ko-KR" sz="71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omo</a:t>
            </a:r>
            <a:r>
              <a:rPr lang="en-US" altLang="ko-KR" sz="71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ko-KR" sz="710" b="1" dirty="0">
                <a:latin typeface="Arial" panose="020B0604020202020204" pitchFamily="34" charset="0"/>
                <a:cs typeface="Arial" panose="020B0604020202020204" pitchFamily="34" charset="0"/>
              </a:rPr>
              <a:t>M]</a:t>
            </a:r>
            <a:endParaRPr lang="ko-KR" altLang="en-US" sz="71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tangle 43"/>
          <p:cNvSpPr/>
          <p:nvPr/>
        </p:nvSpPr>
        <p:spPr>
          <a:xfrm>
            <a:off x="190651" y="7470498"/>
            <a:ext cx="649643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</a:t>
            </a:r>
            <a:r>
              <a:rPr lang="en-US" sz="140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5. </a:t>
            </a:r>
            <a:r>
              <a:rPr lang="en-US" sz="14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ose-response curves (DRCs) of reference drugs 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rom </a:t>
            </a:r>
            <a:r>
              <a:rPr lang="en-US" sz="1400" i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L. </a:t>
            </a:r>
            <a:r>
              <a:rPr lang="en-US" sz="1400" i="1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onovani</a:t>
            </a:r>
            <a:r>
              <a:rPr lang="en-US" sz="14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-infected THP-1</a:t>
            </a:r>
            <a:r>
              <a:rPr lang="en-US" sz="14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C of (A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C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tefosin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E) SSG, and (G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omomyci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osures to THP-1 infected with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novani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astigotes. DRC of (B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p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D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ltefosin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F) SSG, and (H)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omomycin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osures to THP-1 infected with </a:t>
            </a:r>
            <a:r>
              <a:rPr lang="en-US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onovani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astigotes. Results represent the values with standard deviations from duplicate measurement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87053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92" t="7239" r="28534" b="42788"/>
          <a:stretch/>
        </p:blipFill>
        <p:spPr>
          <a:xfrm>
            <a:off x="711950" y="3302948"/>
            <a:ext cx="2878429" cy="287842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04" t="7349" r="28424" b="42680"/>
          <a:stretch/>
        </p:blipFill>
        <p:spPr>
          <a:xfrm>
            <a:off x="711950" y="6265571"/>
            <a:ext cx="2878428" cy="2878429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0" y="4526"/>
            <a:ext cx="222663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5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ko-KR" sz="1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93" t="7239" r="28534" b="42788"/>
          <a:stretch/>
        </p:blipFill>
        <p:spPr>
          <a:xfrm>
            <a:off x="711950" y="340324"/>
            <a:ext cx="2878429" cy="287842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81" t="7239" r="28646" b="42788"/>
          <a:stretch/>
        </p:blipFill>
        <p:spPr>
          <a:xfrm>
            <a:off x="3979571" y="340324"/>
            <a:ext cx="2878428" cy="287842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92" t="7353" r="28534" b="42674"/>
          <a:stretch/>
        </p:blipFill>
        <p:spPr>
          <a:xfrm>
            <a:off x="3979571" y="3302948"/>
            <a:ext cx="2878429" cy="2878429"/>
          </a:xfrm>
          <a:prstGeom prst="rect">
            <a:avLst/>
          </a:prstGeom>
        </p:spPr>
      </p:pic>
      <p:sp>
        <p:nvSpPr>
          <p:cNvPr id="30" name="Right Arrow 29"/>
          <p:cNvSpPr/>
          <p:nvPr/>
        </p:nvSpPr>
        <p:spPr>
          <a:xfrm>
            <a:off x="3495845" y="1545538"/>
            <a:ext cx="576000" cy="468000"/>
          </a:xfrm>
          <a:prstGeom prst="rightArrow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ight Arrow 30"/>
          <p:cNvSpPr/>
          <p:nvPr/>
        </p:nvSpPr>
        <p:spPr>
          <a:xfrm flipH="1">
            <a:off x="3495845" y="4508162"/>
            <a:ext cx="576000" cy="468000"/>
          </a:xfrm>
          <a:prstGeom prst="rightArrow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ight Arrow 31"/>
          <p:cNvSpPr/>
          <p:nvPr/>
        </p:nvSpPr>
        <p:spPr>
          <a:xfrm rot="5400000">
            <a:off x="5130785" y="2995661"/>
            <a:ext cx="576000" cy="468000"/>
          </a:xfrm>
          <a:prstGeom prst="rightArrow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ight Arrow 32"/>
          <p:cNvSpPr/>
          <p:nvPr/>
        </p:nvSpPr>
        <p:spPr>
          <a:xfrm rot="5400000">
            <a:off x="1863164" y="5993458"/>
            <a:ext cx="576000" cy="468000"/>
          </a:xfrm>
          <a:prstGeom prst="rightArrow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TextBox 33"/>
          <p:cNvSpPr txBox="1"/>
          <p:nvPr/>
        </p:nvSpPr>
        <p:spPr>
          <a:xfrm>
            <a:off x="406126" y="33788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406126" y="33057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3683094" y="33057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14142" y="627445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683094" y="34036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Straight Connector 45"/>
          <p:cNvCxnSpPr>
            <a:cxnSpLocks noChangeAspect="1"/>
          </p:cNvCxnSpPr>
          <p:nvPr/>
        </p:nvCxnSpPr>
        <p:spPr>
          <a:xfrm>
            <a:off x="2984302" y="3131919"/>
            <a:ext cx="576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4" name="Picture 5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53" t="26230" r="57502" b="62326"/>
          <a:stretch/>
        </p:blipFill>
        <p:spPr>
          <a:xfrm>
            <a:off x="3979571" y="6265571"/>
            <a:ext cx="2880000" cy="2879999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1262606" y="4371598"/>
            <a:ext cx="658800" cy="658800"/>
          </a:xfrm>
          <a:prstGeom prst="rect">
            <a:avLst/>
          </a:prstGeom>
          <a:noFill/>
          <a:ln w="19050"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6" name="Straight Connector 55"/>
          <p:cNvCxnSpPr>
            <a:cxnSpLocks noChangeAspect="1"/>
          </p:cNvCxnSpPr>
          <p:nvPr/>
        </p:nvCxnSpPr>
        <p:spPr>
          <a:xfrm>
            <a:off x="6318447" y="9059971"/>
            <a:ext cx="5004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3683094" y="6274459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tangle 57"/>
          <p:cNvSpPr>
            <a:spLocks noChangeAspect="1"/>
          </p:cNvSpPr>
          <p:nvPr/>
        </p:nvSpPr>
        <p:spPr>
          <a:xfrm>
            <a:off x="1262606" y="1419536"/>
            <a:ext cx="658800" cy="658800"/>
          </a:xfrm>
          <a:prstGeom prst="rect">
            <a:avLst/>
          </a:prstGeom>
          <a:noFill/>
          <a:ln w="19050"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Rectangle 58"/>
          <p:cNvSpPr>
            <a:spLocks noChangeAspect="1"/>
          </p:cNvSpPr>
          <p:nvPr/>
        </p:nvSpPr>
        <p:spPr>
          <a:xfrm>
            <a:off x="1262606" y="7335453"/>
            <a:ext cx="658800" cy="658800"/>
          </a:xfrm>
          <a:prstGeom prst="rect">
            <a:avLst/>
          </a:prstGeom>
          <a:noFill/>
          <a:ln w="19050"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Rectangle 59"/>
          <p:cNvSpPr>
            <a:spLocks noChangeAspect="1"/>
          </p:cNvSpPr>
          <p:nvPr/>
        </p:nvSpPr>
        <p:spPr>
          <a:xfrm>
            <a:off x="4540761" y="4371598"/>
            <a:ext cx="658800" cy="658800"/>
          </a:xfrm>
          <a:prstGeom prst="rect">
            <a:avLst/>
          </a:prstGeom>
          <a:noFill/>
          <a:ln w="19050"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/>
          <p:cNvSpPr>
            <a:spLocks noChangeAspect="1"/>
          </p:cNvSpPr>
          <p:nvPr/>
        </p:nvSpPr>
        <p:spPr>
          <a:xfrm>
            <a:off x="4540761" y="1419536"/>
            <a:ext cx="658800" cy="658800"/>
          </a:xfrm>
          <a:prstGeom prst="rect">
            <a:avLst/>
          </a:prstGeom>
          <a:noFill/>
          <a:ln w="19050"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7" name="Straight Connector 26"/>
          <p:cNvCxnSpPr>
            <a:cxnSpLocks noChangeAspect="1"/>
          </p:cNvCxnSpPr>
          <p:nvPr/>
        </p:nvCxnSpPr>
        <p:spPr>
          <a:xfrm>
            <a:off x="2984302" y="6095945"/>
            <a:ext cx="576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>
            <a:cxnSpLocks noChangeAspect="1"/>
          </p:cNvCxnSpPr>
          <p:nvPr/>
        </p:nvCxnSpPr>
        <p:spPr>
          <a:xfrm>
            <a:off x="2984302" y="9059971"/>
            <a:ext cx="576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>
            <a:cxnSpLocks noChangeAspect="1"/>
          </p:cNvCxnSpPr>
          <p:nvPr/>
        </p:nvCxnSpPr>
        <p:spPr>
          <a:xfrm>
            <a:off x="6242847" y="6095945"/>
            <a:ext cx="576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>
            <a:cxnSpLocks noChangeAspect="1"/>
          </p:cNvCxnSpPr>
          <p:nvPr/>
        </p:nvCxnSpPr>
        <p:spPr>
          <a:xfrm>
            <a:off x="6242847" y="3131919"/>
            <a:ext cx="5760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9104628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7800" y="262466"/>
            <a:ext cx="652780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age analysis of intracellular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ishmania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y Columbus softwar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Draq-5-stained image of THP-1 infected with 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azonensis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mastigotes at 96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pi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B) Detection of large-sized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cleus of host cells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raq-5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. (C) The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st cell boundary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sking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formed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low-intensity Draq-5 signals from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tosols. (D) Detection of small-sized nucleus of parasites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Draq-5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ignals within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rea of masked host cell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E) Detection of infected host cells (in green) and non-infected host cells (in red). (F) Enlarged infected cell image from (D), yellow dotted square. Scale bar, 50 </a:t>
            </a:r>
            <a:r>
              <a:rPr lang="el-G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 for (A) to (E) and 10 </a:t>
            </a:r>
            <a:r>
              <a:rPr lang="el-G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for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F)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3076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80</TotalTime>
  <Words>1170</Words>
  <Application>Microsoft Office PowerPoint</Application>
  <PresentationFormat>Letter Paper (8.5x11 in)</PresentationFormat>
  <Paragraphs>285</Paragraphs>
  <Slides>8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맑은 고딕</vt:lpstr>
      <vt:lpstr>Arial</vt:lpstr>
      <vt:lpstr>Calibri</vt:lpstr>
      <vt:lpstr>Calibri Light</vt:lpstr>
      <vt:lpstr>Times New Roman</vt:lpstr>
      <vt:lpstr>Office Theme</vt:lpstr>
      <vt:lpstr>Prism 6</vt:lpstr>
      <vt:lpstr>Supporting inform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unghwa Baek</dc:creator>
  <cp:lastModifiedBy>Kyunghwa Baek</cp:lastModifiedBy>
  <cp:revision>119</cp:revision>
  <cp:lastPrinted>2020-04-17T00:06:01Z</cp:lastPrinted>
  <dcterms:created xsi:type="dcterms:W3CDTF">2019-05-23T05:12:04Z</dcterms:created>
  <dcterms:modified xsi:type="dcterms:W3CDTF">2020-04-28T05:42:29Z</dcterms:modified>
</cp:coreProperties>
</file>